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5" d="100"/>
          <a:sy n="105" d="100"/>
        </p:scale>
        <p:origin x="1188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cifs-ac.ukessen.local\ac-home\diehoyer\SeaFile\Seafile\Meine%20Bibliothek\Sequencing\Klinische_Daten_Sequencing_Auswertung1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cifs-ac.ukessen.local\ac-home\diehoyer\SeaFile\Seafile\Meine%20Bibliothek\Sequencing\Klinische_Daten_Sequencing_Auswertung1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de-DE" sz="1100"/>
              <a:t>Hepatocellular injury</a:t>
            </a:r>
            <a:r>
              <a:rPr lang="de-DE" sz="1100" baseline="0"/>
              <a:t> </a:t>
            </a:r>
            <a:r>
              <a:rPr lang="de-DE" sz="1100"/>
              <a:t>after LT</a:t>
            </a:r>
          </a:p>
        </c:rich>
      </c:tx>
      <c:layout>
        <c:manualLayout>
          <c:xMode val="edge"/>
          <c:yMode val="edge"/>
          <c:x val="0.35140459588815304"/>
          <c:y val="2.8222254711529761E-2"/>
        </c:manualLayout>
      </c:layout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v>AST</c:v>
          </c:tx>
          <c:spPr>
            <a:ln w="22225"/>
          </c:spPr>
          <c:errBars>
            <c:errDir val="y"/>
            <c:errBarType val="both"/>
            <c:errValType val="cust"/>
            <c:noEndCap val="0"/>
            <c:plus>
              <c:numRef>
                <c:f>'Auswertung Variablen nach Grupp'!$DV$11:$EB$11</c:f>
                <c:numCache>
                  <c:formatCode>General</c:formatCode>
                  <c:ptCount val="7"/>
                  <c:pt idx="0">
                    <c:v>205.72933675098457</c:v>
                  </c:pt>
                  <c:pt idx="1">
                    <c:v>112.78315477055961</c:v>
                  </c:pt>
                  <c:pt idx="2">
                    <c:v>43.424186808735982</c:v>
                  </c:pt>
                  <c:pt idx="3">
                    <c:v>20.724381776062703</c:v>
                  </c:pt>
                  <c:pt idx="4">
                    <c:v>11.183022847155415</c:v>
                  </c:pt>
                  <c:pt idx="5">
                    <c:v>8.6174242091242075</c:v>
                  </c:pt>
                  <c:pt idx="6">
                    <c:v>11.034491379306976</c:v>
                  </c:pt>
                </c:numCache>
              </c:numRef>
            </c:plus>
            <c:minus>
              <c:numRef>
                <c:f>'Auswertung Variablen nach Grupp'!$DV$11:$EB$11</c:f>
                <c:numCache>
                  <c:formatCode>General</c:formatCode>
                  <c:ptCount val="7"/>
                  <c:pt idx="0">
                    <c:v>205.72933675098457</c:v>
                  </c:pt>
                  <c:pt idx="1">
                    <c:v>112.78315477055961</c:v>
                  </c:pt>
                  <c:pt idx="2">
                    <c:v>43.424186808735982</c:v>
                  </c:pt>
                  <c:pt idx="3">
                    <c:v>20.724381776062703</c:v>
                  </c:pt>
                  <c:pt idx="4">
                    <c:v>11.183022847155415</c:v>
                  </c:pt>
                  <c:pt idx="5">
                    <c:v>8.6174242091242075</c:v>
                  </c:pt>
                  <c:pt idx="6">
                    <c:v>11.034491379306976</c:v>
                  </c:pt>
                </c:numCache>
              </c:numRef>
            </c:minus>
            <c:spPr>
              <a:ln>
                <a:solidFill>
                  <a:schemeClr val="accent1">
                    <a:shade val="95000"/>
                    <a:satMod val="105000"/>
                  </a:schemeClr>
                </a:solidFill>
              </a:ln>
            </c:spPr>
          </c:errBars>
          <c:cat>
            <c:strRef>
              <c:f>'Auswertung Variablen nach Grupp'!$DV$12:$EB$12</c:f>
              <c:strCache>
                <c:ptCount val="7"/>
                <c:pt idx="0">
                  <c:v>POP1</c:v>
                </c:pt>
                <c:pt idx="1">
                  <c:v>POP2</c:v>
                </c:pt>
                <c:pt idx="2">
                  <c:v>POP3</c:v>
                </c:pt>
                <c:pt idx="3">
                  <c:v>POP4</c:v>
                </c:pt>
                <c:pt idx="4">
                  <c:v>POP5</c:v>
                </c:pt>
                <c:pt idx="5">
                  <c:v>POP6</c:v>
                </c:pt>
                <c:pt idx="6">
                  <c:v>POP7</c:v>
                </c:pt>
              </c:strCache>
            </c:strRef>
          </c:cat>
          <c:val>
            <c:numRef>
              <c:f>'Auswertung Variablen nach Grupp'!$DV$10:$EB$10</c:f>
              <c:numCache>
                <c:formatCode>General</c:formatCode>
                <c:ptCount val="7"/>
                <c:pt idx="0">
                  <c:v>998.6</c:v>
                </c:pt>
                <c:pt idx="1">
                  <c:v>473.8</c:v>
                </c:pt>
                <c:pt idx="2">
                  <c:v>231.4</c:v>
                </c:pt>
                <c:pt idx="3">
                  <c:v>101</c:v>
                </c:pt>
                <c:pt idx="4">
                  <c:v>58.4</c:v>
                </c:pt>
                <c:pt idx="5">
                  <c:v>39.4</c:v>
                </c:pt>
                <c:pt idx="6">
                  <c:v>37.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DB7-4058-8AA9-3783479140C2}"/>
            </c:ext>
          </c:extLst>
        </c:ser>
        <c:ser>
          <c:idx val="1"/>
          <c:order val="1"/>
          <c:tx>
            <c:v>ALT</c:v>
          </c:tx>
          <c:spPr>
            <a:ln w="22225">
              <a:solidFill>
                <a:srgbClr val="00B050"/>
              </a:solidFill>
            </a:ln>
          </c:spPr>
          <c:marker>
            <c:symbol val="square"/>
            <c:size val="5"/>
            <c:spPr>
              <a:solidFill>
                <a:srgbClr val="92D050"/>
              </a:solidFill>
              <a:ln>
                <a:solidFill>
                  <a:srgbClr val="00B05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Auswertung Variablen nach Grupp'!$EC$11:$EI$11</c:f>
                <c:numCache>
                  <c:formatCode>General</c:formatCode>
                  <c:ptCount val="7"/>
                  <c:pt idx="0">
                    <c:v>141.4416487460465</c:v>
                  </c:pt>
                  <c:pt idx="1">
                    <c:v>107.6831463136177</c:v>
                  </c:pt>
                  <c:pt idx="2">
                    <c:v>63.366079253808955</c:v>
                  </c:pt>
                  <c:pt idx="3">
                    <c:v>53.319414850502632</c:v>
                  </c:pt>
                  <c:pt idx="4">
                    <c:v>41.760028735622299</c:v>
                  </c:pt>
                  <c:pt idx="5">
                    <c:v>33.275516524916632</c:v>
                  </c:pt>
                  <c:pt idx="6">
                    <c:v>35.251382951594962</c:v>
                  </c:pt>
                </c:numCache>
              </c:numRef>
            </c:plus>
            <c:minus>
              <c:numRef>
                <c:f>'Auswertung Variablen nach Grupp'!$EC$11:$EI$11</c:f>
                <c:numCache>
                  <c:formatCode>General</c:formatCode>
                  <c:ptCount val="7"/>
                  <c:pt idx="0">
                    <c:v>141.4416487460465</c:v>
                  </c:pt>
                  <c:pt idx="1">
                    <c:v>107.6831463136177</c:v>
                  </c:pt>
                  <c:pt idx="2">
                    <c:v>63.366079253808955</c:v>
                  </c:pt>
                  <c:pt idx="3">
                    <c:v>53.319414850502632</c:v>
                  </c:pt>
                  <c:pt idx="4">
                    <c:v>41.760028735622299</c:v>
                  </c:pt>
                  <c:pt idx="5">
                    <c:v>33.275516524916632</c:v>
                  </c:pt>
                  <c:pt idx="6">
                    <c:v>35.251382951594962</c:v>
                  </c:pt>
                </c:numCache>
              </c:numRef>
            </c:minus>
            <c:spPr>
              <a:ln>
                <a:solidFill>
                  <a:srgbClr val="00B050"/>
                </a:solidFill>
              </a:ln>
            </c:spPr>
          </c:errBars>
          <c:val>
            <c:numRef>
              <c:f>'Auswertung Variablen nach Grupp'!$EC$10:$EI$10</c:f>
              <c:numCache>
                <c:formatCode>General</c:formatCode>
                <c:ptCount val="7"/>
                <c:pt idx="0">
                  <c:v>569.79999999999995</c:v>
                </c:pt>
                <c:pt idx="1">
                  <c:v>462.4</c:v>
                </c:pt>
                <c:pt idx="2">
                  <c:v>366.4</c:v>
                </c:pt>
                <c:pt idx="3">
                  <c:v>267.60000000000002</c:v>
                </c:pt>
                <c:pt idx="4">
                  <c:v>195</c:v>
                </c:pt>
                <c:pt idx="5">
                  <c:v>143.4</c:v>
                </c:pt>
                <c:pt idx="6">
                  <c:v>122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BDB7-4058-8AA9-3783479140C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02615128"/>
        <c:axId val="1"/>
      </c:lineChart>
      <c:catAx>
        <c:axId val="4026151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U/l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402615128"/>
        <c:crosses val="autoZero"/>
        <c:crossBetween val="between"/>
      </c:valAx>
    </c:plotArea>
    <c:legend>
      <c:legendPos val="b"/>
      <c:layout/>
      <c:overlay val="0"/>
      <c:txPr>
        <a:bodyPr/>
        <a:lstStyle/>
        <a:p>
          <a:pPr>
            <a:defRPr sz="900"/>
          </a:pPr>
          <a:endParaRPr lang="de-DE"/>
        </a:p>
      </c:txPr>
    </c:legend>
    <c:plotVisOnly val="1"/>
    <c:dispBlanksAs val="gap"/>
    <c:showDLblsOverMax val="0"/>
  </c:chart>
  <c:txPr>
    <a:bodyPr/>
    <a:lstStyle/>
    <a:p>
      <a:pPr>
        <a:defRPr b="1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de-DE" sz="1100"/>
              <a:t>Liver function after LT</a:t>
            </a:r>
          </a:p>
        </c:rich>
      </c:tx>
      <c:layout>
        <c:manualLayout>
          <c:xMode val="edge"/>
          <c:yMode val="edge"/>
          <c:x val="0.35140459588815304"/>
          <c:y val="2.8222254711529761E-2"/>
        </c:manualLayout>
      </c:layout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v>INR</c:v>
          </c:tx>
          <c:spPr>
            <a:ln w="22225"/>
          </c:spPr>
          <c:errBars>
            <c:errDir val="y"/>
            <c:errBarType val="both"/>
            <c:errValType val="cust"/>
            <c:noEndCap val="0"/>
            <c:plus>
              <c:numRef>
                <c:f>'Auswertung Variablen nach Grupp'!$EJ$11:$EP$11</c:f>
                <c:numCache>
                  <c:formatCode>General</c:formatCode>
                  <c:ptCount val="7"/>
                  <c:pt idx="0">
                    <c:v>0.26855911825890416</c:v>
                  </c:pt>
                  <c:pt idx="1">
                    <c:v>8.4403791384036225E-2</c:v>
                  </c:pt>
                  <c:pt idx="2">
                    <c:v>3.8392707640904931E-2</c:v>
                  </c:pt>
                  <c:pt idx="3">
                    <c:v>2.5768197453450273E-2</c:v>
                  </c:pt>
                  <c:pt idx="4">
                    <c:v>2.6720778431774801E-2</c:v>
                  </c:pt>
                  <c:pt idx="5">
                    <c:v>2.4622144504490281E-2</c:v>
                  </c:pt>
                  <c:pt idx="6">
                    <c:v>3.3316662497915393E-2</c:v>
                  </c:pt>
                </c:numCache>
              </c:numRef>
            </c:plus>
            <c:minus>
              <c:numRef>
                <c:f>'Auswertung Variablen nach Grupp'!$EJ$11:$EP$11</c:f>
                <c:numCache>
                  <c:formatCode>General</c:formatCode>
                  <c:ptCount val="7"/>
                  <c:pt idx="0">
                    <c:v>0.26855911825890416</c:v>
                  </c:pt>
                  <c:pt idx="1">
                    <c:v>8.4403791384036225E-2</c:v>
                  </c:pt>
                  <c:pt idx="2">
                    <c:v>3.8392707640904931E-2</c:v>
                  </c:pt>
                  <c:pt idx="3">
                    <c:v>2.5768197453450273E-2</c:v>
                  </c:pt>
                  <c:pt idx="4">
                    <c:v>2.6720778431774801E-2</c:v>
                  </c:pt>
                  <c:pt idx="5">
                    <c:v>2.4622144504490281E-2</c:v>
                  </c:pt>
                  <c:pt idx="6">
                    <c:v>3.3316662497915393E-2</c:v>
                  </c:pt>
                </c:numCache>
              </c:numRef>
            </c:minus>
            <c:spPr>
              <a:ln>
                <a:solidFill>
                  <a:schemeClr val="accent1">
                    <a:shade val="95000"/>
                    <a:satMod val="105000"/>
                  </a:schemeClr>
                </a:solidFill>
              </a:ln>
            </c:spPr>
          </c:errBars>
          <c:cat>
            <c:strRef>
              <c:f>'Auswertung Variablen nach Grupp'!$DV$12:$EB$12</c:f>
              <c:strCache>
                <c:ptCount val="7"/>
                <c:pt idx="0">
                  <c:v>POP1</c:v>
                </c:pt>
                <c:pt idx="1">
                  <c:v>POP2</c:v>
                </c:pt>
                <c:pt idx="2">
                  <c:v>POP3</c:v>
                </c:pt>
                <c:pt idx="3">
                  <c:v>POP4</c:v>
                </c:pt>
                <c:pt idx="4">
                  <c:v>POP5</c:v>
                </c:pt>
                <c:pt idx="5">
                  <c:v>POP6</c:v>
                </c:pt>
                <c:pt idx="6">
                  <c:v>POP7</c:v>
                </c:pt>
              </c:strCache>
            </c:strRef>
          </c:cat>
          <c:val>
            <c:numRef>
              <c:f>'Auswertung Variablen nach Grupp'!$EJ$10:$EP$10</c:f>
              <c:numCache>
                <c:formatCode>General</c:formatCode>
                <c:ptCount val="7"/>
                <c:pt idx="0">
                  <c:v>1.6320000000000001</c:v>
                </c:pt>
                <c:pt idx="1">
                  <c:v>1.1880000000000002</c:v>
                </c:pt>
                <c:pt idx="2">
                  <c:v>1.0419999999999998</c:v>
                </c:pt>
                <c:pt idx="3">
                  <c:v>1.008</c:v>
                </c:pt>
                <c:pt idx="4">
                  <c:v>1.028</c:v>
                </c:pt>
                <c:pt idx="5">
                  <c:v>1.0125</c:v>
                </c:pt>
                <c:pt idx="6">
                  <c:v>1.010000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54F-47D4-8C24-9E5DC41C5A9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02617752"/>
        <c:axId val="1"/>
      </c:lineChart>
      <c:lineChart>
        <c:grouping val="standard"/>
        <c:varyColors val="0"/>
        <c:ser>
          <c:idx val="1"/>
          <c:order val="1"/>
          <c:tx>
            <c:v>Bilirubin</c:v>
          </c:tx>
          <c:spPr>
            <a:ln w="22225">
              <a:solidFill>
                <a:srgbClr val="00B050"/>
              </a:solidFill>
            </a:ln>
          </c:spPr>
          <c:marker>
            <c:symbol val="square"/>
            <c:size val="5"/>
            <c:spPr>
              <a:solidFill>
                <a:srgbClr val="92D050"/>
              </a:solidFill>
              <a:ln>
                <a:solidFill>
                  <a:srgbClr val="00B05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Auswertung Variablen nach Grupp'!$FE$11:$FK$11</c:f>
                <c:numCache>
                  <c:formatCode>General</c:formatCode>
                  <c:ptCount val="7"/>
                  <c:pt idx="0">
                    <c:v>0.47159304490206377</c:v>
                  </c:pt>
                  <c:pt idx="1">
                    <c:v>8.6023252670426167E-2</c:v>
                  </c:pt>
                  <c:pt idx="2">
                    <c:v>0.11999999999999995</c:v>
                  </c:pt>
                  <c:pt idx="3">
                    <c:v>0.17146428199482242</c:v>
                  </c:pt>
                  <c:pt idx="4">
                    <c:v>9.7979589711327267E-2</c:v>
                  </c:pt>
                  <c:pt idx="5">
                    <c:v>0.17492855684535902</c:v>
                  </c:pt>
                  <c:pt idx="6">
                    <c:v>5.8309518948453022E-2</c:v>
                  </c:pt>
                </c:numCache>
              </c:numRef>
            </c:plus>
            <c:minus>
              <c:numRef>
                <c:f>'Auswertung Variablen nach Grupp'!$FE$11:$FK$11</c:f>
                <c:numCache>
                  <c:formatCode>General</c:formatCode>
                  <c:ptCount val="7"/>
                  <c:pt idx="0">
                    <c:v>0.47159304490206377</c:v>
                  </c:pt>
                  <c:pt idx="1">
                    <c:v>8.6023252670426167E-2</c:v>
                  </c:pt>
                  <c:pt idx="2">
                    <c:v>0.11999999999999995</c:v>
                  </c:pt>
                  <c:pt idx="3">
                    <c:v>0.17146428199482242</c:v>
                  </c:pt>
                  <c:pt idx="4">
                    <c:v>9.7979589711327267E-2</c:v>
                  </c:pt>
                  <c:pt idx="5">
                    <c:v>0.17492855684535902</c:v>
                  </c:pt>
                  <c:pt idx="6">
                    <c:v>5.8309518948453022E-2</c:v>
                  </c:pt>
                </c:numCache>
              </c:numRef>
            </c:minus>
            <c:spPr>
              <a:ln>
                <a:solidFill>
                  <a:srgbClr val="00B050"/>
                </a:solidFill>
              </a:ln>
            </c:spPr>
          </c:errBars>
          <c:val>
            <c:numRef>
              <c:f>'Auswertung Variablen nach Grupp'!$FE$10:$FK$10</c:f>
              <c:numCache>
                <c:formatCode>General</c:formatCode>
                <c:ptCount val="7"/>
                <c:pt idx="0">
                  <c:v>1.6800000000000002</c:v>
                </c:pt>
                <c:pt idx="1">
                  <c:v>0.68</c:v>
                </c:pt>
                <c:pt idx="2">
                  <c:v>0.62</c:v>
                </c:pt>
                <c:pt idx="3">
                  <c:v>0.72</c:v>
                </c:pt>
                <c:pt idx="4">
                  <c:v>0.74</c:v>
                </c:pt>
                <c:pt idx="5">
                  <c:v>0.74</c:v>
                </c:pt>
                <c:pt idx="6">
                  <c:v>0.6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54F-47D4-8C24-9E5DC41C5A9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"/>
        <c:axId val="4"/>
      </c:lineChart>
      <c:catAx>
        <c:axId val="4026177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  <c:min val="0.9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INR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402617752"/>
        <c:crosses val="autoZero"/>
        <c:crossBetween val="between"/>
        <c:majorUnit val="0.2"/>
      </c:valAx>
      <c:catAx>
        <c:axId val="3"/>
        <c:scaling>
          <c:orientation val="minMax"/>
        </c:scaling>
        <c:delete val="1"/>
        <c:axPos val="b"/>
        <c:majorTickMark val="out"/>
        <c:minorTickMark val="none"/>
        <c:tickLblPos val="nextTo"/>
        <c:crossAx val="4"/>
        <c:crosses val="autoZero"/>
        <c:auto val="1"/>
        <c:lblAlgn val="ctr"/>
        <c:lblOffset val="100"/>
        <c:noMultiLvlLbl val="0"/>
      </c:catAx>
      <c:valAx>
        <c:axId val="4"/>
        <c:scaling>
          <c:orientation val="minMax"/>
          <c:min val="0.30000000000000004"/>
        </c:scaling>
        <c:delete val="0"/>
        <c:axPos val="r"/>
        <c:title>
          <c:tx>
            <c:rich>
              <a:bodyPr rot="5400000" vert="horz"/>
              <a:lstStyle/>
              <a:p>
                <a:pPr>
                  <a:defRPr/>
                </a:pPr>
                <a:r>
                  <a:rPr lang="en-US"/>
                  <a:t>Bilirubin (mg/dl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3"/>
        <c:crosses val="max"/>
        <c:crossBetween val="between"/>
      </c:valAx>
    </c:plotArea>
    <c:legend>
      <c:legendPos val="b"/>
      <c:layout/>
      <c:overlay val="0"/>
      <c:txPr>
        <a:bodyPr/>
        <a:lstStyle/>
        <a:p>
          <a:pPr>
            <a:defRPr sz="900"/>
          </a:pPr>
          <a:endParaRPr lang="de-DE"/>
        </a:p>
      </c:txPr>
    </c:legend>
    <c:plotVisOnly val="1"/>
    <c:dispBlanksAs val="gap"/>
    <c:showDLblsOverMax val="0"/>
  </c:chart>
  <c:txPr>
    <a:bodyPr/>
    <a:lstStyle/>
    <a:p>
      <a:pPr>
        <a:defRPr b="1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5E3C4-5163-4961-ABED-A4EB1DA18CB8}" type="datetimeFigureOut">
              <a:rPr lang="de-DE" smtClean="0"/>
              <a:t>10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5AAD42-D158-46DE-8F4D-838B08B64BA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956881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5E3C4-5163-4961-ABED-A4EB1DA18CB8}" type="datetimeFigureOut">
              <a:rPr lang="de-DE" smtClean="0"/>
              <a:t>10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5AAD42-D158-46DE-8F4D-838B08B64BA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781251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5E3C4-5163-4961-ABED-A4EB1DA18CB8}" type="datetimeFigureOut">
              <a:rPr lang="de-DE" smtClean="0"/>
              <a:t>10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5AAD42-D158-46DE-8F4D-838B08B64BA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050447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5E3C4-5163-4961-ABED-A4EB1DA18CB8}" type="datetimeFigureOut">
              <a:rPr lang="de-DE" smtClean="0"/>
              <a:t>10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5AAD42-D158-46DE-8F4D-838B08B64BA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115380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5E3C4-5163-4961-ABED-A4EB1DA18CB8}" type="datetimeFigureOut">
              <a:rPr lang="de-DE" smtClean="0"/>
              <a:t>10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5AAD42-D158-46DE-8F4D-838B08B64BA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451240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5E3C4-5163-4961-ABED-A4EB1DA18CB8}" type="datetimeFigureOut">
              <a:rPr lang="de-DE" smtClean="0"/>
              <a:t>10.08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5AAD42-D158-46DE-8F4D-838B08B64BA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567274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5E3C4-5163-4961-ABED-A4EB1DA18CB8}" type="datetimeFigureOut">
              <a:rPr lang="de-DE" smtClean="0"/>
              <a:t>10.08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5AAD42-D158-46DE-8F4D-838B08B64BA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113924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5E3C4-5163-4961-ABED-A4EB1DA18CB8}" type="datetimeFigureOut">
              <a:rPr lang="de-DE" smtClean="0"/>
              <a:t>10.08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5AAD42-D158-46DE-8F4D-838B08B64BA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478739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5E3C4-5163-4961-ABED-A4EB1DA18CB8}" type="datetimeFigureOut">
              <a:rPr lang="de-DE" smtClean="0"/>
              <a:t>10.08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5AAD42-D158-46DE-8F4D-838B08B64BA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279955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5E3C4-5163-4961-ABED-A4EB1DA18CB8}" type="datetimeFigureOut">
              <a:rPr lang="de-DE" smtClean="0"/>
              <a:t>10.08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5AAD42-D158-46DE-8F4D-838B08B64BA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337544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5E3C4-5163-4961-ABED-A4EB1DA18CB8}" type="datetimeFigureOut">
              <a:rPr lang="de-DE" smtClean="0"/>
              <a:t>10.08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5AAD42-D158-46DE-8F4D-838B08B64BA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045638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25E3C4-5163-4961-ABED-A4EB1DA18CB8}" type="datetimeFigureOut">
              <a:rPr lang="de-DE" smtClean="0"/>
              <a:t>10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5AAD42-D158-46DE-8F4D-838B08B64BA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885423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/>
          <p:cNvSpPr txBox="1"/>
          <p:nvPr/>
        </p:nvSpPr>
        <p:spPr>
          <a:xfrm>
            <a:off x="1115616" y="6021288"/>
            <a:ext cx="669674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Supplement Figure </a:t>
            </a:r>
            <a:r>
              <a:rPr lang="en-US" sz="1400" b="1" dirty="0" smtClean="0"/>
              <a:t>1 </a:t>
            </a:r>
            <a:r>
              <a:rPr lang="en-US" sz="1400" b="1" dirty="0" smtClean="0"/>
              <a:t>A</a:t>
            </a:r>
            <a:r>
              <a:rPr lang="en-US" sz="1400" b="1" dirty="0" smtClean="0"/>
              <a:t/>
            </a:r>
            <a:br>
              <a:rPr lang="en-US" sz="1400" b="1" dirty="0" smtClean="0"/>
            </a:br>
            <a:r>
              <a:rPr lang="en-US" sz="1400" dirty="0" smtClean="0"/>
              <a:t>Hepatocellular injury after LT in COR treated patients</a:t>
            </a:r>
            <a:endParaRPr lang="en-US" sz="1400" dirty="0"/>
          </a:p>
        </p:txBody>
      </p:sp>
      <p:graphicFrame>
        <p:nvGraphicFramePr>
          <p:cNvPr id="4" name="Diagramm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92660804"/>
              </p:ext>
            </p:extLst>
          </p:nvPr>
        </p:nvGraphicFramePr>
        <p:xfrm>
          <a:off x="1259632" y="1340768"/>
          <a:ext cx="6000750" cy="36004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8129496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/>
          <p:cNvSpPr txBox="1"/>
          <p:nvPr/>
        </p:nvSpPr>
        <p:spPr>
          <a:xfrm>
            <a:off x="1115616" y="6021288"/>
            <a:ext cx="669674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 Figure 1 </a:t>
            </a:r>
            <a:r>
              <a:rPr lang="en-US" sz="1400" b="1" dirty="0" smtClean="0"/>
              <a:t>B</a:t>
            </a:r>
            <a:r>
              <a:rPr lang="en-US" sz="1400" b="1" dirty="0" smtClean="0"/>
              <a:t/>
            </a:r>
            <a:br>
              <a:rPr lang="en-US" sz="1400" b="1" dirty="0" smtClean="0"/>
            </a:br>
            <a:r>
              <a:rPr lang="en-US" sz="1400" dirty="0" smtClean="0"/>
              <a:t>Liver function after LT in COR treated patients</a:t>
            </a:r>
            <a:endParaRPr lang="en-US" sz="1400" dirty="0"/>
          </a:p>
        </p:txBody>
      </p:sp>
      <p:graphicFrame>
        <p:nvGraphicFramePr>
          <p:cNvPr id="4" name="Diagramm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40560677"/>
              </p:ext>
            </p:extLst>
          </p:nvPr>
        </p:nvGraphicFramePr>
        <p:xfrm>
          <a:off x="1571625" y="1628775"/>
          <a:ext cx="6000750" cy="36004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068009574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0</Words>
  <Application>Microsoft Office PowerPoint</Application>
  <PresentationFormat>Bildschirmpräsentation (4:3)</PresentationFormat>
  <Paragraphs>7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5" baseType="lpstr">
      <vt:lpstr>Arial</vt:lpstr>
      <vt:lpstr>Calibri</vt:lpstr>
      <vt:lpstr>Larissa</vt:lpstr>
      <vt:lpstr>PowerPoint-Präsentation</vt:lpstr>
      <vt:lpstr>PowerPoint-Präsentation</vt:lpstr>
    </vt:vector>
  </TitlesOfParts>
  <Company>Universitätsklinikum Ess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ieter P. Hoyer</dc:creator>
  <cp:lastModifiedBy>Dr. med.Hoyer, Dieter Paul</cp:lastModifiedBy>
  <cp:revision>23</cp:revision>
  <dcterms:created xsi:type="dcterms:W3CDTF">2019-08-19T15:39:44Z</dcterms:created>
  <dcterms:modified xsi:type="dcterms:W3CDTF">2020-08-10T14:20:11Z</dcterms:modified>
</cp:coreProperties>
</file>